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4500563" cy="30607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5A2FAE-2751-41F4-A0D1-B9224BA07B3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25000" y="122040"/>
            <a:ext cx="4049640" cy="51084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ctr">
            <a:noAutofit/>
          </a:bodyPr>
          <a:p>
            <a:pPr indent="0" algn="ctr">
              <a:buNone/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25000" y="714240"/>
            <a:ext cx="4049640" cy="96300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25000" y="1769040"/>
            <a:ext cx="4049640" cy="96300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4E9C61-C3F3-4EB4-AAAF-239C60EEB82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25000" y="122040"/>
            <a:ext cx="4049640" cy="51084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ctr">
            <a:noAutofit/>
          </a:bodyPr>
          <a:p>
            <a:pPr indent="0" algn="ctr">
              <a:buNone/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25000" y="714240"/>
            <a:ext cx="1976040" cy="96300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300400" y="714240"/>
            <a:ext cx="1976040" cy="96300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25000" y="1769040"/>
            <a:ext cx="1976040" cy="96300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300400" y="1769040"/>
            <a:ext cx="1976040" cy="96300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925135-113B-4706-9871-F4C5AEF9BEF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25000" y="122040"/>
            <a:ext cx="4049640" cy="51084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ctr">
            <a:noAutofit/>
          </a:bodyPr>
          <a:p>
            <a:pPr indent="0" algn="ctr">
              <a:buNone/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25000" y="714240"/>
            <a:ext cx="1303920" cy="96300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594440" y="714240"/>
            <a:ext cx="1303920" cy="96300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2963880" y="714240"/>
            <a:ext cx="1303920" cy="96300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25000" y="1769040"/>
            <a:ext cx="1303920" cy="96300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594440" y="1769040"/>
            <a:ext cx="1303920" cy="96300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2963880" y="1769040"/>
            <a:ext cx="1303920" cy="96300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1731EB-0A59-477E-AF8F-C22383F3A37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25000" y="122040"/>
            <a:ext cx="4049640" cy="51084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ctr">
            <a:noAutofit/>
          </a:bodyPr>
          <a:p>
            <a:pPr indent="0" algn="ctr">
              <a:buNone/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25000" y="714240"/>
            <a:ext cx="4049640" cy="2019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374"/>
              </a:spcBef>
              <a:buNone/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2ED66C-9811-4965-BA8E-AD55A397E8B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25000" y="122040"/>
            <a:ext cx="4049640" cy="51084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ctr">
            <a:noAutofit/>
          </a:bodyPr>
          <a:p>
            <a:pPr indent="0" algn="ctr">
              <a:buNone/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25000" y="714240"/>
            <a:ext cx="4049640" cy="201960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9BE55E-8BDB-4E2D-97B9-035A57F6955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25000" y="122040"/>
            <a:ext cx="4049640" cy="51084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ctr">
            <a:noAutofit/>
          </a:bodyPr>
          <a:p>
            <a:pPr indent="0" algn="ctr">
              <a:buNone/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25000" y="714240"/>
            <a:ext cx="1976040" cy="201960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300400" y="714240"/>
            <a:ext cx="1976040" cy="201960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51F911-05D9-4FFF-AF4A-EE5C3F7FAEA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25000" y="122040"/>
            <a:ext cx="4049640" cy="51084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ctr">
            <a:noAutofit/>
          </a:bodyPr>
          <a:p>
            <a:pPr indent="0" algn="ctr">
              <a:buNone/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3C0A52-098C-48DE-B775-DC544CBE2A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25000" y="122040"/>
            <a:ext cx="4049640" cy="2369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374"/>
              </a:spcBef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8CA732-F3A3-4347-AE4C-330EB12DE9C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25000" y="122040"/>
            <a:ext cx="4049640" cy="51084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ctr">
            <a:noAutofit/>
          </a:bodyPr>
          <a:p>
            <a:pPr indent="0" algn="ctr">
              <a:buNone/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25000" y="714240"/>
            <a:ext cx="1976040" cy="96300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300400" y="714240"/>
            <a:ext cx="1976040" cy="201960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25000" y="1769040"/>
            <a:ext cx="1976040" cy="96300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5C2776-B9F4-4134-8480-E72324C281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25000" y="122040"/>
            <a:ext cx="4049640" cy="51084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ctr">
            <a:noAutofit/>
          </a:bodyPr>
          <a:p>
            <a:pPr indent="0" algn="ctr">
              <a:buNone/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25000" y="714240"/>
            <a:ext cx="1976040" cy="201960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300400" y="714240"/>
            <a:ext cx="1976040" cy="96300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300400" y="1769040"/>
            <a:ext cx="1976040" cy="96300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ACD16E-4BE4-486A-9DF1-1E729016CC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25000" y="122040"/>
            <a:ext cx="4049640" cy="51084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ctr">
            <a:noAutofit/>
          </a:bodyPr>
          <a:p>
            <a:pPr indent="0" algn="ctr">
              <a:buNone/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25000" y="714240"/>
            <a:ext cx="1976040" cy="96300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300400" y="714240"/>
            <a:ext cx="1976040" cy="96300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25000" y="1769040"/>
            <a:ext cx="4049640" cy="96300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F01205-29FF-4EC8-B743-2E4E0B981B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25000" y="122040"/>
            <a:ext cx="4049640" cy="51084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ctr">
            <a:noAutofit/>
          </a:bodyPr>
          <a:p>
            <a:pPr indent="0" algn="ctr">
              <a:buNone/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25000" y="714240"/>
            <a:ext cx="4049640" cy="201960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t">
            <a:normAutofit/>
          </a:bodyPr>
          <a:p>
            <a:pPr marL="157320" indent="-157320">
              <a:spcBef>
                <a:spcPts val="374"/>
              </a:spcBef>
              <a:buClr>
                <a:srgbClr val="000000"/>
              </a:buClr>
              <a:buFont typeface="Arial"/>
              <a:buChar char="•"/>
              <a:tabLst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  <a:p>
            <a:pPr lvl="1" marL="341280" indent="-131760">
              <a:spcBef>
                <a:spcPts val="374"/>
              </a:spcBef>
              <a:buClr>
                <a:srgbClr val="000000"/>
              </a:buClr>
              <a:buFont typeface="Arial"/>
              <a:buChar char="–"/>
              <a:tabLst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  <a:p>
            <a:pPr lvl="2" marL="527040" indent="-104760">
              <a:spcBef>
                <a:spcPts val="374"/>
              </a:spcBef>
              <a:buClr>
                <a:srgbClr val="000000"/>
              </a:buClr>
              <a:buFont typeface="Arial"/>
              <a:buChar char="•"/>
              <a:tabLst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  <a:p>
            <a:pPr lvl="3" marL="736560" indent="-104760">
              <a:spcBef>
                <a:spcPts val="374"/>
              </a:spcBef>
              <a:buClr>
                <a:srgbClr val="000000"/>
              </a:buClr>
              <a:buFont typeface="Arial"/>
              <a:buChar char="–"/>
              <a:tabLst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  <a:p>
            <a:pPr lvl="4" marL="947880" indent="-104760">
              <a:spcBef>
                <a:spcPts val="374"/>
              </a:spcBef>
              <a:buClr>
                <a:srgbClr val="000000"/>
              </a:buClr>
              <a:buFont typeface="Arial"/>
              <a:buChar char="»"/>
              <a:tabLst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  <a:p>
            <a:pPr lvl="5" marL="947880" indent="-104760">
              <a:spcBef>
                <a:spcPts val="374"/>
              </a:spcBef>
              <a:buClr>
                <a:srgbClr val="000000"/>
              </a:buClr>
              <a:buFont typeface="Arial"/>
              <a:buChar char="»"/>
              <a:tabLst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  <a:p>
            <a:pPr lvl="6" marL="947880" indent="-104760">
              <a:spcBef>
                <a:spcPts val="374"/>
              </a:spcBef>
              <a:buClr>
                <a:srgbClr val="000000"/>
              </a:buClr>
              <a:buFont typeface="Arial"/>
              <a:buChar char="»"/>
              <a:tabLst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25000" y="2836800"/>
            <a:ext cx="1049400" cy="16344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ctr">
            <a:noAutofit/>
          </a:bodyPr>
          <a:lstStyle>
            <a:lvl1pPr indent="0">
              <a:buNone/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  <a:defRPr b="0" lang="en-US" sz="6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r>
              <a:rPr b="0" lang="en-US" sz="6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538280" y="2836800"/>
            <a:ext cx="1424160" cy="16344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ctr">
            <a:noAutofit/>
          </a:bodyPr>
          <a:p>
            <a:pPr indent="0">
              <a:buNone/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225960" y="2836800"/>
            <a:ext cx="1049040" cy="163440"/>
          </a:xfrm>
          <a:prstGeom prst="rect">
            <a:avLst/>
          </a:prstGeom>
          <a:noFill/>
          <a:ln w="0">
            <a:noFill/>
          </a:ln>
        </p:spPr>
        <p:txBody>
          <a:bodyPr lIns="42120" rIns="42120" tIns="21240" bIns="21240" anchor="ctr">
            <a:noAutofit/>
          </a:bodyPr>
          <a:lstStyle>
            <a:lvl1pPr indent="0" algn="r">
              <a:buNone/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  <a:defRPr b="0" lang="en-US" sz="6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fld id="{17CE4826-599A-4F17-8126-F571B9390683}" type="slidenum">
              <a:rPr b="0" lang="en-US" sz="6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3"/>
          <p:cNvSpPr/>
          <p:nvPr/>
        </p:nvSpPr>
        <p:spPr>
          <a:xfrm>
            <a:off x="14400" y="6480"/>
            <a:ext cx="5078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dditional table 1.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tatistical analysis of organelle densities within filament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24"/>
          <p:cNvSpPr/>
          <p:nvPr/>
        </p:nvSpPr>
        <p:spPr>
          <a:xfrm>
            <a:off x="17640" y="119700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hloroplast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25"/>
          <p:cNvSpPr/>
          <p:nvPr/>
        </p:nvSpPr>
        <p:spPr>
          <a:xfrm>
            <a:off x="871560" y="396720"/>
            <a:ext cx="4027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ip of apical cell vs. base of sub-apical cel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26"/>
          <p:cNvSpPr/>
          <p:nvPr/>
        </p:nvSpPr>
        <p:spPr>
          <a:xfrm>
            <a:off x="23760" y="150192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eroxisome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27"/>
          <p:cNvSpPr/>
          <p:nvPr/>
        </p:nvSpPr>
        <p:spPr>
          <a:xfrm>
            <a:off x="31680" y="180648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Golgi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28"/>
          <p:cNvSpPr/>
          <p:nvPr/>
        </p:nvSpPr>
        <p:spPr>
          <a:xfrm>
            <a:off x="33480" y="211140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itochondri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29"/>
          <p:cNvSpPr/>
          <p:nvPr/>
        </p:nvSpPr>
        <p:spPr>
          <a:xfrm>
            <a:off x="1336680" y="78408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aulonemat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30"/>
          <p:cNvSpPr/>
          <p:nvPr/>
        </p:nvSpPr>
        <p:spPr>
          <a:xfrm>
            <a:off x="3160800" y="78408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hloronemat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Straight Connector 31"/>
          <p:cNvSpPr/>
          <p:nvPr/>
        </p:nvSpPr>
        <p:spPr>
          <a:xfrm>
            <a:off x="98280" y="311040"/>
            <a:ext cx="43894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Straight Connector 32"/>
          <p:cNvSpPr/>
          <p:nvPr/>
        </p:nvSpPr>
        <p:spPr>
          <a:xfrm>
            <a:off x="98280" y="2432160"/>
            <a:ext cx="43894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33"/>
          <p:cNvSpPr/>
          <p:nvPr/>
        </p:nvSpPr>
        <p:spPr>
          <a:xfrm>
            <a:off x="14400" y="2502000"/>
            <a:ext cx="446544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djusted P values are shown for rejecting equivalence of means by t-test; values in bold indicate that the difference is statistically significant at the 0.05 level.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Straight Connector 34"/>
          <p:cNvSpPr/>
          <p:nvPr/>
        </p:nvSpPr>
        <p:spPr>
          <a:xfrm>
            <a:off x="1279440" y="711360"/>
            <a:ext cx="3200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35"/>
          <p:cNvSpPr/>
          <p:nvPr/>
        </p:nvSpPr>
        <p:spPr>
          <a:xfrm>
            <a:off x="1341360" y="119556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&lt;0.000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36"/>
          <p:cNvSpPr/>
          <p:nvPr/>
        </p:nvSpPr>
        <p:spPr>
          <a:xfrm>
            <a:off x="3170160" y="119556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&lt;0.000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37"/>
          <p:cNvSpPr/>
          <p:nvPr/>
        </p:nvSpPr>
        <p:spPr>
          <a:xfrm>
            <a:off x="1343160" y="150192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069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38"/>
          <p:cNvSpPr/>
          <p:nvPr/>
        </p:nvSpPr>
        <p:spPr>
          <a:xfrm>
            <a:off x="3171960" y="150192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0475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39"/>
          <p:cNvSpPr/>
          <p:nvPr/>
        </p:nvSpPr>
        <p:spPr>
          <a:xfrm>
            <a:off x="1341360" y="180648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&lt;0.000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40"/>
          <p:cNvSpPr/>
          <p:nvPr/>
        </p:nvSpPr>
        <p:spPr>
          <a:xfrm>
            <a:off x="3170160" y="180648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0264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41"/>
          <p:cNvSpPr/>
          <p:nvPr/>
        </p:nvSpPr>
        <p:spPr>
          <a:xfrm>
            <a:off x="1332000" y="210168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0022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42"/>
          <p:cNvSpPr/>
          <p:nvPr/>
        </p:nvSpPr>
        <p:spPr>
          <a:xfrm>
            <a:off x="3160800" y="210168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20840"/>
                <a:tab algn="l" pos="841320"/>
                <a:tab algn="l" pos="1262160"/>
                <a:tab algn="l" pos="1682640"/>
                <a:tab algn="l" pos="2103480"/>
                <a:tab algn="l" pos="2523960"/>
                <a:tab algn="l" pos="2944800"/>
                <a:tab algn="l" pos="3365640"/>
                <a:tab algn="l" pos="3786120"/>
                <a:tab algn="l" pos="4206960"/>
                <a:tab algn="l" pos="4627440"/>
                <a:tab algn="l" pos="5048280"/>
                <a:tab algn="l" pos="5468760"/>
                <a:tab algn="l" pos="5889600"/>
                <a:tab algn="l" pos="6310440"/>
                <a:tab algn="l" pos="6730920"/>
                <a:tab algn="l" pos="7151760"/>
                <a:tab algn="l" pos="7572240"/>
                <a:tab algn="l" pos="7993080"/>
                <a:tab algn="l" pos="84139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0146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29T00:27:43Z</dcterms:created>
  <dc:creator>fabiennefurt</dc:creator>
  <dc:description/>
  <dc:language>en-US</dc:language>
  <cp:lastModifiedBy>Furt, Fabienne</cp:lastModifiedBy>
  <dcterms:modified xsi:type="dcterms:W3CDTF">2012-02-29T03:16:08Z</dcterms:modified>
  <cp:revision>2</cp:revision>
  <dc:subject/>
  <dc:title>PowerPoint Presentation</dc:title>
</cp:coreProperties>
</file>